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3" d="100"/>
          <a:sy n="83" d="100"/>
        </p:scale>
        <p:origin x="1387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papaefthymiou@o365.uth.gr" userId="9fc4bb3a-9f47-4932-b338-1082eb2e432c" providerId="ADAL" clId="{036BF051-6D56-4B37-8005-E4C190AAD278}"/>
    <pc:docChg chg="modSld">
      <pc:chgData name="mpapaefthymiou@o365.uth.gr" userId="9fc4bb3a-9f47-4932-b338-1082eb2e432c" providerId="ADAL" clId="{036BF051-6D56-4B37-8005-E4C190AAD278}" dt="2024-05-22T09:42:57.536" v="0" actId="255"/>
      <pc:docMkLst>
        <pc:docMk/>
      </pc:docMkLst>
      <pc:sldChg chg="modSp mod">
        <pc:chgData name="mpapaefthymiou@o365.uth.gr" userId="9fc4bb3a-9f47-4932-b338-1082eb2e432c" providerId="ADAL" clId="{036BF051-6D56-4B37-8005-E4C190AAD278}" dt="2024-05-22T09:42:57.536" v="0" actId="255"/>
        <pc:sldMkLst>
          <pc:docMk/>
          <pc:sldMk cId="2768936493" sldId="257"/>
        </pc:sldMkLst>
        <pc:spChg chg="mod">
          <ac:chgData name="mpapaefthymiou@o365.uth.gr" userId="9fc4bb3a-9f47-4932-b338-1082eb2e432c" providerId="ADAL" clId="{036BF051-6D56-4B37-8005-E4C190AAD278}" dt="2024-05-22T09:42:57.536" v="0" actId="255"/>
          <ac:spMkLst>
            <pc:docMk/>
            <pc:sldMk cId="2768936493" sldId="257"/>
            <ac:spMk id="2" creationId="{62000569-6031-3155-301F-D7CBADC69047}"/>
          </ac:spMkLst>
        </pc:spChg>
      </pc:sldChg>
    </pc:docChg>
  </pc:docChgLst>
  <pc:docChgLst>
    <pc:chgData name="PAPAEFTHYMIOU MARIA" userId="9fc4bb3a-9f47-4932-b338-1082eb2e432c" providerId="ADAL" clId="{217AC531-4220-4AE6-AF61-CAC9B107E895}"/>
    <pc:docChg chg="delSld modSld">
      <pc:chgData name="PAPAEFTHYMIOU MARIA" userId="9fc4bb3a-9f47-4932-b338-1082eb2e432c" providerId="ADAL" clId="{217AC531-4220-4AE6-AF61-CAC9B107E895}" dt="2024-04-23T09:08:51.906" v="109" actId="1076"/>
      <pc:docMkLst>
        <pc:docMk/>
      </pc:docMkLst>
      <pc:sldChg chg="del">
        <pc:chgData name="PAPAEFTHYMIOU MARIA" userId="9fc4bb3a-9f47-4932-b338-1082eb2e432c" providerId="ADAL" clId="{217AC531-4220-4AE6-AF61-CAC9B107E895}" dt="2024-04-23T08:44:56.117" v="2" actId="2696"/>
        <pc:sldMkLst>
          <pc:docMk/>
          <pc:sldMk cId="3437771836" sldId="256"/>
        </pc:sldMkLst>
      </pc:sldChg>
      <pc:sldChg chg="addSp delSp modSp mod">
        <pc:chgData name="PAPAEFTHYMIOU MARIA" userId="9fc4bb3a-9f47-4932-b338-1082eb2e432c" providerId="ADAL" clId="{217AC531-4220-4AE6-AF61-CAC9B107E895}" dt="2024-04-23T09:08:51.906" v="109" actId="1076"/>
        <pc:sldMkLst>
          <pc:docMk/>
          <pc:sldMk cId="2768936493" sldId="257"/>
        </pc:sldMkLst>
        <pc:spChg chg="mod">
          <ac:chgData name="PAPAEFTHYMIOU MARIA" userId="9fc4bb3a-9f47-4932-b338-1082eb2e432c" providerId="ADAL" clId="{217AC531-4220-4AE6-AF61-CAC9B107E895}" dt="2024-04-23T09:07:47.858" v="108" actId="20577"/>
          <ac:spMkLst>
            <pc:docMk/>
            <pc:sldMk cId="2768936493" sldId="257"/>
            <ac:spMk id="2" creationId="{62000569-6031-3155-301F-D7CBADC69047}"/>
          </ac:spMkLst>
        </pc:spChg>
        <pc:spChg chg="mod topLvl">
          <ac:chgData name="PAPAEFTHYMIOU MARIA" userId="9fc4bb3a-9f47-4932-b338-1082eb2e432c" providerId="ADAL" clId="{217AC531-4220-4AE6-AF61-CAC9B107E895}" dt="2024-04-23T09:08:51.906" v="109" actId="1076"/>
          <ac:spMkLst>
            <pc:docMk/>
            <pc:sldMk cId="2768936493" sldId="257"/>
            <ac:spMk id="3" creationId="{8FA29789-9152-A61E-D820-47551DC0F13B}"/>
          </ac:spMkLst>
        </pc:spChg>
        <pc:spChg chg="add mod">
          <ac:chgData name="PAPAEFTHYMIOU MARIA" userId="9fc4bb3a-9f47-4932-b338-1082eb2e432c" providerId="ADAL" clId="{217AC531-4220-4AE6-AF61-CAC9B107E895}" dt="2024-04-23T09:00:51.617" v="98" actId="114"/>
          <ac:spMkLst>
            <pc:docMk/>
            <pc:sldMk cId="2768936493" sldId="257"/>
            <ac:spMk id="4" creationId="{6CB5E7E7-790C-5880-8777-BA75D32B42FB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6" creationId="{2245CAF8-04D7-6C8A-DC15-BE66060EC826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7" creationId="{4B6DE3C7-8CAB-3343-C033-19F8DE602EC0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8" creationId="{E3B3F85C-A507-FA62-4A4F-9282C65D188F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9" creationId="{BB459F87-C933-3F35-48E9-A6D6BB700A22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0" creationId="{7E87A374-365E-5417-9183-1B7DF9EB97F1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1" creationId="{BAE10BED-958E-D02F-5C62-F8DBF1073BB2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2" creationId="{E3870856-9DE4-D85C-F52E-A27183D5A7C5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3" creationId="{9D7F0453-06C4-897A-EF1A-0C0922F2F24C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4" creationId="{CF801D58-0903-9C6A-D618-071E4D3E8DB3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5" creationId="{3324261F-69A4-D2B3-E73A-1DE8295D3DC2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6" creationId="{F6B8DE4E-9787-A753-71BB-C299E93A6A67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7" creationId="{1055DFC9-1FF8-07D2-41E8-0F33F28DC5AE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8" creationId="{E11D935A-2255-43CE-9751-BE4D680F8859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19" creationId="{2ADCB792-A914-3838-3525-7D76F9AA6F5A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0" creationId="{273E26F9-75BD-FC62-1F94-F6CAB02CF8FA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1" creationId="{D18BCC90-5E19-1B85-7DFA-30B48DF4F5DC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2" creationId="{18033693-C4E5-B5D8-7C7A-122B1A98F328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3" creationId="{45EA3D91-1561-9899-D931-A7AFA231A801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4" creationId="{90D8FCB6-1B55-829E-8CA8-75CAA5D454AB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5" creationId="{8F821065-6CB1-182F-1CDF-1CB5EA153087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6" creationId="{7C154C20-BD0E-2D17-1913-1E521E78F644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7" creationId="{3E616417-EA28-C82B-4522-A2FEAEE74A71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8" creationId="{7B3B1DAE-2B24-2863-F3D1-17F3D730F1A6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29" creationId="{D68BDBFE-E353-75AA-C594-1C5E15E1E51B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0" creationId="{A735EECF-D1A1-1322-5C77-04DAB3B4B5E4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1" creationId="{887D95A8-3AEA-8617-0DFA-C312BCFCDDAD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2" creationId="{2CD314B0-B1A5-652F-AFDA-DE8A898DA446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3" creationId="{31E0385F-D5B2-C47D-32B3-2773ABF86558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4" creationId="{F48F1182-A3BE-6C2E-9D2B-CB7D7E697F6C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5" creationId="{DA95B35A-62AC-2D83-F549-54A02334519C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6" creationId="{6BFE236F-0CC5-8677-C50B-C0A79DC70F61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7" creationId="{09C74407-0FFC-92D2-9512-5D378DC229C1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8" creationId="{D196FB39-CB09-B882-D27C-B8455CA94E6B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39" creationId="{C25F34D4-66FC-EE52-CE8E-271CED8E863C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0" creationId="{A3D3B993-A29F-D03B-6192-B5AEF5E3280E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1" creationId="{3C5DF6F1-8F01-5560-8845-493642ADE8D3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2" creationId="{1F0C2AAC-33A5-EFEE-550E-BD73B3EB1671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3" creationId="{01C3B461-05E1-61A8-89FB-4F060CAB846D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4" creationId="{AA06D743-BB46-7556-520B-9639DBAF58FF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5" creationId="{12193F13-91CC-AEEE-AA35-3BFF5D11CDAC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6" creationId="{F253D3AE-5D4F-25F4-45BF-A22BE034504E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7" creationId="{2ECD4870-4AF9-6797-3513-B8C20D69C3DD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8" creationId="{B2C28416-7840-5D69-E010-CC3154F27D46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49" creationId="{BFD3EACF-6F3D-33E9-4CFC-CE0E761B6E35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50" creationId="{29AF7CB1-28DE-EFFC-9F2C-C186E863A369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51" creationId="{741BF1B8-068C-1798-60DF-9166B1E2CF45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52" creationId="{AAC803D0-FAF4-B773-3E8A-53A67905B9EE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54" creationId="{45F557BD-8EB4-8BA1-67DC-1DF2CB59AA86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55" creationId="{6D37A31F-4E7E-1D86-6E3C-FCADBFD7A69A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56" creationId="{8D5E45BC-CF9E-6505-A3EC-14DECDC2A292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58" creationId="{7DC2B59D-5A15-5410-CA1C-4C6F1A6FE831}"/>
          </ac:spMkLst>
        </pc:spChg>
        <pc:spChg chg="mod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59" creationId="{8D7D9209-39CE-2A44-E40F-F33333B54D46}"/>
          </ac:spMkLst>
        </pc:spChg>
        <pc:spChg chg="mod topLvl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64" creationId="{CF8D88B8-A3DD-32E2-213D-257EEDB8EBE9}"/>
          </ac:spMkLst>
        </pc:spChg>
        <pc:spChg chg="mod topLvl">
          <ac:chgData name="PAPAEFTHYMIOU MARIA" userId="9fc4bb3a-9f47-4932-b338-1082eb2e432c" providerId="ADAL" clId="{217AC531-4220-4AE6-AF61-CAC9B107E895}" dt="2024-04-23T08:40:28.228" v="1" actId="165"/>
          <ac:spMkLst>
            <pc:docMk/>
            <pc:sldMk cId="2768936493" sldId="257"/>
            <ac:spMk id="66" creationId="{0AFD1FDF-A6F5-7634-E602-B8961E774B0C}"/>
          </ac:spMkLst>
        </pc:spChg>
        <pc:grpChg chg="del">
          <ac:chgData name="PAPAEFTHYMIOU MARIA" userId="9fc4bb3a-9f47-4932-b338-1082eb2e432c" providerId="ADAL" clId="{217AC531-4220-4AE6-AF61-CAC9B107E895}" dt="2024-04-23T08:40:28.228" v="1" actId="165"/>
          <ac:grpSpMkLst>
            <pc:docMk/>
            <pc:sldMk cId="2768936493" sldId="257"/>
            <ac:grpSpMk id="4" creationId="{08E8C03C-E752-B5B0-68C2-D991B4939C0E}"/>
          </ac:grpSpMkLst>
        </pc:grpChg>
        <pc:grpChg chg="mod topLvl">
          <ac:chgData name="PAPAEFTHYMIOU MARIA" userId="9fc4bb3a-9f47-4932-b338-1082eb2e432c" providerId="ADAL" clId="{217AC531-4220-4AE6-AF61-CAC9B107E895}" dt="2024-04-23T08:40:28.228" v="1" actId="165"/>
          <ac:grpSpMkLst>
            <pc:docMk/>
            <pc:sldMk cId="2768936493" sldId="257"/>
            <ac:grpSpMk id="5" creationId="{DBD6029E-1D04-F88E-B9F2-ACA86F85A1C3}"/>
          </ac:grpSpMkLst>
        </pc:grpChg>
      </pc:sldChg>
    </pc:docChg>
  </pc:docChgLst>
  <pc:docChgLst>
    <pc:chgData name="PAPAEFTHYMIOU MARIA" userId="9fc4bb3a-9f47-4932-b338-1082eb2e432c" providerId="ADAL" clId="{C9546E65-D04E-455F-83E4-655937DBF733}"/>
    <pc:docChg chg="undo custSel modSld">
      <pc:chgData name="PAPAEFTHYMIOU MARIA" userId="9fc4bb3a-9f47-4932-b338-1082eb2e432c" providerId="ADAL" clId="{C9546E65-D04E-455F-83E4-655937DBF733}" dt="2024-04-23T08:06:17.138" v="1" actId="6549"/>
      <pc:docMkLst>
        <pc:docMk/>
      </pc:docMkLst>
      <pc:sldChg chg="modSp mod">
        <pc:chgData name="PAPAEFTHYMIOU MARIA" userId="9fc4bb3a-9f47-4932-b338-1082eb2e432c" providerId="ADAL" clId="{C9546E65-D04E-455F-83E4-655937DBF733}" dt="2024-04-23T08:06:17.138" v="1" actId="6549"/>
        <pc:sldMkLst>
          <pc:docMk/>
          <pc:sldMk cId="2768936493" sldId="257"/>
        </pc:sldMkLst>
        <pc:spChg chg="mod">
          <ac:chgData name="PAPAEFTHYMIOU MARIA" userId="9fc4bb3a-9f47-4932-b338-1082eb2e432c" providerId="ADAL" clId="{C9546E65-D04E-455F-83E4-655937DBF733}" dt="2024-04-23T08:06:17.138" v="1" actId="6549"/>
          <ac:spMkLst>
            <pc:docMk/>
            <pc:sldMk cId="2768936493" sldId="257"/>
            <ac:spMk id="48" creationId="{B2C28416-7840-5D69-E010-CC3154F27D46}"/>
          </ac:spMkLst>
        </pc:spChg>
      </pc:sldChg>
    </pc:docChg>
  </pc:docChgLst>
  <pc:docChgLst>
    <pc:chgData name="PAPAEFTHYMIOU MARIA" userId="9fc4bb3a-9f47-4932-b338-1082eb2e432c" providerId="ADAL" clId="{8150595F-2354-44E4-BBA2-ADDB1C9B6AA8}"/>
    <pc:docChg chg="undo custSel modSld">
      <pc:chgData name="PAPAEFTHYMIOU MARIA" userId="9fc4bb3a-9f47-4932-b338-1082eb2e432c" providerId="ADAL" clId="{8150595F-2354-44E4-BBA2-ADDB1C9B6AA8}" dt="2024-03-26T20:44:11.009" v="127" actId="1076"/>
      <pc:docMkLst>
        <pc:docMk/>
      </pc:docMkLst>
      <pc:sldChg chg="modSp mod">
        <pc:chgData name="PAPAEFTHYMIOU MARIA" userId="9fc4bb3a-9f47-4932-b338-1082eb2e432c" providerId="ADAL" clId="{8150595F-2354-44E4-BBA2-ADDB1C9B6AA8}" dt="2024-03-24T18:53:58.067" v="52" actId="1076"/>
        <pc:sldMkLst>
          <pc:docMk/>
          <pc:sldMk cId="3437771836" sldId="256"/>
        </pc:sldMkLst>
        <pc:spChg chg="mod">
          <ac:chgData name="PAPAEFTHYMIOU MARIA" userId="9fc4bb3a-9f47-4932-b338-1082eb2e432c" providerId="ADAL" clId="{8150595F-2354-44E4-BBA2-ADDB1C9B6AA8}" dt="2024-03-24T18:53:58.067" v="52" actId="1076"/>
          <ac:spMkLst>
            <pc:docMk/>
            <pc:sldMk cId="3437771836" sldId="256"/>
            <ac:spMk id="6" creationId="{A0F2F4C3-F136-8671-EF05-B62FAE8C355E}"/>
          </ac:spMkLst>
        </pc:spChg>
      </pc:sldChg>
      <pc:sldChg chg="addSp delSp modSp mod">
        <pc:chgData name="PAPAEFTHYMIOU MARIA" userId="9fc4bb3a-9f47-4932-b338-1082eb2e432c" providerId="ADAL" clId="{8150595F-2354-44E4-BBA2-ADDB1C9B6AA8}" dt="2024-03-26T20:44:11.009" v="127" actId="1076"/>
        <pc:sldMkLst>
          <pc:docMk/>
          <pc:sldMk cId="2768936493" sldId="257"/>
        </pc:sldMkLst>
        <pc:spChg chg="add mod">
          <ac:chgData name="PAPAEFTHYMIOU MARIA" userId="9fc4bb3a-9f47-4932-b338-1082eb2e432c" providerId="ADAL" clId="{8150595F-2354-44E4-BBA2-ADDB1C9B6AA8}" dt="2024-03-26T20:43:49.890" v="126" actId="1076"/>
          <ac:spMkLst>
            <pc:docMk/>
            <pc:sldMk cId="2768936493" sldId="257"/>
            <ac:spMk id="2" creationId="{62000569-6031-3155-301F-D7CBADC69047}"/>
          </ac:spMkLst>
        </pc:spChg>
        <pc:spChg chg="add 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" creationId="{8FA29789-9152-A61E-D820-47551DC0F13B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6" creationId="{2245CAF8-04D7-6C8A-DC15-BE66060EC826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7" creationId="{4B6DE3C7-8CAB-3343-C033-19F8DE602EC0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8" creationId="{E3B3F85C-A507-FA62-4A4F-9282C65D188F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9" creationId="{BB459F87-C933-3F35-48E9-A6D6BB700A22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0" creationId="{7E87A374-365E-5417-9183-1B7DF9EB97F1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1" creationId="{BAE10BED-958E-D02F-5C62-F8DBF1073BB2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2" creationId="{E3870856-9DE4-D85C-F52E-A27183D5A7C5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3" creationId="{9D7F0453-06C4-897A-EF1A-0C0922F2F24C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4" creationId="{CF801D58-0903-9C6A-D618-071E4D3E8DB3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5" creationId="{3324261F-69A4-D2B3-E73A-1DE8295D3DC2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6" creationId="{F6B8DE4E-9787-A753-71BB-C299E93A6A67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7" creationId="{1055DFC9-1FF8-07D2-41E8-0F33F28DC5AE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8" creationId="{E11D935A-2255-43CE-9751-BE4D680F8859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19" creationId="{2ADCB792-A914-3838-3525-7D76F9AA6F5A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0" creationId="{273E26F9-75BD-FC62-1F94-F6CAB02CF8FA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1" creationId="{D18BCC90-5E19-1B85-7DFA-30B48DF4F5DC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2" creationId="{18033693-C4E5-B5D8-7C7A-122B1A98F328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3" creationId="{45EA3D91-1561-9899-D931-A7AFA231A801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4" creationId="{90D8FCB6-1B55-829E-8CA8-75CAA5D454AB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5" creationId="{8F821065-6CB1-182F-1CDF-1CB5EA153087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6" creationId="{7C154C20-BD0E-2D17-1913-1E521E78F644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7" creationId="{3E616417-EA28-C82B-4522-A2FEAEE74A71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8" creationId="{7B3B1DAE-2B24-2863-F3D1-17F3D730F1A6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29" creationId="{D68BDBFE-E353-75AA-C594-1C5E15E1E51B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0" creationId="{A735EECF-D1A1-1322-5C77-04DAB3B4B5E4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1" creationId="{887D95A8-3AEA-8617-0DFA-C312BCFCDDAD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2" creationId="{2CD314B0-B1A5-652F-AFDA-DE8A898DA446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3" creationId="{31E0385F-D5B2-C47D-32B3-2773ABF86558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4" creationId="{F48F1182-A3BE-6C2E-9D2B-CB7D7E697F6C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5" creationId="{DA95B35A-62AC-2D83-F549-54A02334519C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6" creationId="{6BFE236F-0CC5-8677-C50B-C0A79DC70F61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7" creationId="{09C74407-0FFC-92D2-9512-5D378DC229C1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8" creationId="{D196FB39-CB09-B882-D27C-B8455CA94E6B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39" creationId="{C25F34D4-66FC-EE52-CE8E-271CED8E863C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0" creationId="{A3D3B993-A29F-D03B-6192-B5AEF5E3280E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1" creationId="{3C5DF6F1-8F01-5560-8845-493642ADE8D3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2" creationId="{1F0C2AAC-33A5-EFEE-550E-BD73B3EB1671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3" creationId="{01C3B461-05E1-61A8-89FB-4F060CAB846D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4" creationId="{AA06D743-BB46-7556-520B-9639DBAF58FF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5" creationId="{12193F13-91CC-AEEE-AA35-3BFF5D11CDAC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6" creationId="{F253D3AE-5D4F-25F4-45BF-A22BE034504E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7" creationId="{2ECD4870-4AF9-6797-3513-B8C20D69C3DD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8" creationId="{B2C28416-7840-5D69-E010-CC3154F27D46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49" creationId="{BFD3EACF-6F3D-33E9-4CFC-CE0E761B6E35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50" creationId="{29AF7CB1-28DE-EFFC-9F2C-C186E863A369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51" creationId="{741BF1B8-068C-1798-60DF-9166B1E2CF45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52" creationId="{AAC803D0-FAF4-B773-3E8A-53A67905B9EE}"/>
          </ac:spMkLst>
        </pc:spChg>
        <pc:spChg chg="del mod">
          <ac:chgData name="PAPAEFTHYMIOU MARIA" userId="9fc4bb3a-9f47-4932-b338-1082eb2e432c" providerId="ADAL" clId="{8150595F-2354-44E4-BBA2-ADDB1C9B6AA8}" dt="2024-03-24T10:40:04.490" v="16" actId="21"/>
          <ac:spMkLst>
            <pc:docMk/>
            <pc:sldMk cId="2768936493" sldId="257"/>
            <ac:spMk id="53" creationId="{6943702B-0A81-7490-6862-D2EC4FDD18D3}"/>
          </ac:spMkLst>
        </pc:spChg>
        <pc:spChg chg="add mod">
          <ac:chgData name="PAPAEFTHYMIOU MARIA" userId="9fc4bb3a-9f47-4932-b338-1082eb2e432c" providerId="ADAL" clId="{8150595F-2354-44E4-BBA2-ADDB1C9B6AA8}" dt="2024-03-26T05:57:46.075" v="116"/>
          <ac:spMkLst>
            <pc:docMk/>
            <pc:sldMk cId="2768936493" sldId="257"/>
            <ac:spMk id="53" creationId="{8C0B4DCE-E190-46A8-18EB-FF5ECDAED4EF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54" creationId="{45F557BD-8EB4-8BA1-67DC-1DF2CB59AA86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55" creationId="{6D37A31F-4E7E-1D86-6E3C-FCADBFD7A69A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56" creationId="{8D5E45BC-CF9E-6505-A3EC-14DECDC2A292}"/>
          </ac:spMkLst>
        </pc:spChg>
        <pc:spChg chg="del mod">
          <ac:chgData name="PAPAEFTHYMIOU MARIA" userId="9fc4bb3a-9f47-4932-b338-1082eb2e432c" providerId="ADAL" clId="{8150595F-2354-44E4-BBA2-ADDB1C9B6AA8}" dt="2024-03-24T10:40:07.815" v="17" actId="21"/>
          <ac:spMkLst>
            <pc:docMk/>
            <pc:sldMk cId="2768936493" sldId="257"/>
            <ac:spMk id="57" creationId="{78DEAFDE-B253-2DB1-A88B-A560E0A2D5F9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58" creationId="{7DC2B59D-5A15-5410-CA1C-4C6F1A6FE831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59" creationId="{8D7D9209-39CE-2A44-E40F-F33333B54D46}"/>
          </ac:spMkLst>
        </pc:spChg>
        <pc:spChg chg="del mod">
          <ac:chgData name="PAPAEFTHYMIOU MARIA" userId="9fc4bb3a-9f47-4932-b338-1082eb2e432c" providerId="ADAL" clId="{8150595F-2354-44E4-BBA2-ADDB1C9B6AA8}" dt="2024-03-24T10:39:24.291" v="11" actId="478"/>
          <ac:spMkLst>
            <pc:docMk/>
            <pc:sldMk cId="2768936493" sldId="257"/>
            <ac:spMk id="60" creationId="{8D921084-2497-340A-97D2-F44D58E54353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64" creationId="{CF8D88B8-A3DD-32E2-213D-257EEDB8EBE9}"/>
          </ac:spMkLst>
        </pc:spChg>
        <pc:spChg chg="mod">
          <ac:chgData name="PAPAEFTHYMIOU MARIA" userId="9fc4bb3a-9f47-4932-b338-1082eb2e432c" providerId="ADAL" clId="{8150595F-2354-44E4-BBA2-ADDB1C9B6AA8}" dt="2024-03-26T20:44:11.009" v="127" actId="1076"/>
          <ac:spMkLst>
            <pc:docMk/>
            <pc:sldMk cId="2768936493" sldId="257"/>
            <ac:spMk id="66" creationId="{0AFD1FDF-A6F5-7634-E602-B8961E774B0C}"/>
          </ac:spMkLst>
        </pc:spChg>
        <pc:grpChg chg="add mod">
          <ac:chgData name="PAPAEFTHYMIOU MARIA" userId="9fc4bb3a-9f47-4932-b338-1082eb2e432c" providerId="ADAL" clId="{8150595F-2354-44E4-BBA2-ADDB1C9B6AA8}" dt="2024-03-26T20:44:11.009" v="127" actId="1076"/>
          <ac:grpSpMkLst>
            <pc:docMk/>
            <pc:sldMk cId="2768936493" sldId="257"/>
            <ac:grpSpMk id="4" creationId="{08E8C03C-E752-B5B0-68C2-D991B4939C0E}"/>
          </ac:grpSpMkLst>
        </pc:grpChg>
        <pc:grpChg chg="mod">
          <ac:chgData name="PAPAEFTHYMIOU MARIA" userId="9fc4bb3a-9f47-4932-b338-1082eb2e432c" providerId="ADAL" clId="{8150595F-2354-44E4-BBA2-ADDB1C9B6AA8}" dt="2024-03-26T20:44:11.009" v="127" actId="1076"/>
          <ac:grpSpMkLst>
            <pc:docMk/>
            <pc:sldMk cId="2768936493" sldId="257"/>
            <ac:grpSpMk id="5" creationId="{DBD6029E-1D04-F88E-B9F2-ACA86F85A1C3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18794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7989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98162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05753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75333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75108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92388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62297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90939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96015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47208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7BFEAB3-62C0-48A8-800D-1FAE3F68C2FD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787DA5-72B6-4595-AA2E-8DEFCE5CD03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83743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000569-6031-3155-301F-D7CBADC69047}"/>
              </a:ext>
            </a:extLst>
          </p:cNvPr>
          <p:cNvSpPr txBox="1"/>
          <p:nvPr/>
        </p:nvSpPr>
        <p:spPr>
          <a:xfrm>
            <a:off x="182263" y="502797"/>
            <a:ext cx="88899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Meta-regression analysis of concentration (as effect size) for DPPH assay for </a:t>
            </a:r>
            <a:r>
              <a:rPr lang="en-US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ydroalcoholic </a:t>
            </a:r>
            <a:r>
              <a:rPr lang="en-US" sz="1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tracts</a:t>
            </a:r>
            <a:endParaRPr lang="en-US" sz="1200" dirty="0"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BD6029E-1D04-F88E-B9F2-ACA86F85A1C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081088" y="1405300"/>
            <a:ext cx="5756090" cy="4261371"/>
            <a:chOff x="385" y="1113"/>
            <a:chExt cx="2222" cy="1645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2245CAF8-04D7-6C8A-DC15-BE66060EC826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385" y="1113"/>
              <a:ext cx="2222" cy="16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7" name="Rectangle 5">
              <a:extLst>
                <a:ext uri="{FF2B5EF4-FFF2-40B4-BE49-F238E27FC236}">
                  <a16:creationId xmlns:a16="http://schemas.microsoft.com/office/drawing/2014/main" id="{4B6DE3C7-8CAB-3343-C033-19F8DE602E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" y="1130"/>
              <a:ext cx="2187" cy="1579"/>
            </a:xfrm>
            <a:prstGeom prst="rect">
              <a:avLst/>
            </a:prstGeom>
            <a:solidFill>
              <a:srgbClr val="EAF2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 dirty="0"/>
            </a:p>
          </p:txBody>
        </p:sp>
        <p:sp>
          <p:nvSpPr>
            <p:cNvPr id="8" name="Rectangle 6">
              <a:extLst>
                <a:ext uri="{FF2B5EF4-FFF2-40B4-BE49-F238E27FC236}">
                  <a16:creationId xmlns:a16="http://schemas.microsoft.com/office/drawing/2014/main" id="{E3B3F85C-A507-FA62-4A4F-9282C65D1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" y="1183"/>
              <a:ext cx="2183" cy="1575"/>
            </a:xfrm>
            <a:prstGeom prst="rect">
              <a:avLst/>
            </a:prstGeom>
            <a:solidFill>
              <a:srgbClr val="EAF2F3"/>
            </a:solidFill>
            <a:ln w="4763">
              <a:solidFill>
                <a:srgbClr val="EAF2F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 dirty="0"/>
            </a:p>
          </p:txBody>
        </p:sp>
        <p:sp>
          <p:nvSpPr>
            <p:cNvPr id="9" name="Rectangle 7">
              <a:extLst>
                <a:ext uri="{FF2B5EF4-FFF2-40B4-BE49-F238E27FC236}">
                  <a16:creationId xmlns:a16="http://schemas.microsoft.com/office/drawing/2014/main" id="{BB459F87-C933-3F35-48E9-A6D6BB700A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" y="1188"/>
              <a:ext cx="1911" cy="1306"/>
            </a:xfrm>
            <a:prstGeom prst="rect">
              <a:avLst/>
            </a:prstGeom>
            <a:solidFill>
              <a:srgbClr val="FFFFFF"/>
            </a:solidFill>
            <a:ln w="4763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 dirty="0"/>
            </a:p>
          </p:txBody>
        </p:sp>
        <p:sp>
          <p:nvSpPr>
            <p:cNvPr id="10" name="Line 8">
              <a:extLst>
                <a:ext uri="{FF2B5EF4-FFF2-40B4-BE49-F238E27FC236}">
                  <a16:creationId xmlns:a16="http://schemas.microsoft.com/office/drawing/2014/main" id="{7E87A374-365E-5417-9183-1B7DF9EB97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1" y="2460"/>
              <a:ext cx="1911" cy="0"/>
            </a:xfrm>
            <a:prstGeom prst="line">
              <a:avLst/>
            </a:prstGeom>
            <a:noFill/>
            <a:ln w="7938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1" name="Line 9">
              <a:extLst>
                <a:ext uri="{FF2B5EF4-FFF2-40B4-BE49-F238E27FC236}">
                  <a16:creationId xmlns:a16="http://schemas.microsoft.com/office/drawing/2014/main" id="{BAE10BED-958E-D02F-5C62-F8DBF1073B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1" y="2047"/>
              <a:ext cx="1911" cy="0"/>
            </a:xfrm>
            <a:prstGeom prst="line">
              <a:avLst/>
            </a:prstGeom>
            <a:noFill/>
            <a:ln w="7938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2" name="Line 10">
              <a:extLst>
                <a:ext uri="{FF2B5EF4-FFF2-40B4-BE49-F238E27FC236}">
                  <a16:creationId xmlns:a16="http://schemas.microsoft.com/office/drawing/2014/main" id="{E3870856-9DE4-D85C-F52E-A27183D5A7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1" y="1635"/>
              <a:ext cx="1911" cy="0"/>
            </a:xfrm>
            <a:prstGeom prst="line">
              <a:avLst/>
            </a:prstGeom>
            <a:noFill/>
            <a:ln w="7938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3" name="Line 11">
              <a:extLst>
                <a:ext uri="{FF2B5EF4-FFF2-40B4-BE49-F238E27FC236}">
                  <a16:creationId xmlns:a16="http://schemas.microsoft.com/office/drawing/2014/main" id="{9D7F0453-06C4-897A-EF1A-0C0922F2F2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1" y="1222"/>
              <a:ext cx="1911" cy="0"/>
            </a:xfrm>
            <a:prstGeom prst="line">
              <a:avLst/>
            </a:prstGeom>
            <a:noFill/>
            <a:ln w="7938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4" name="Oval 12">
              <a:extLst>
                <a:ext uri="{FF2B5EF4-FFF2-40B4-BE49-F238E27FC236}">
                  <a16:creationId xmlns:a16="http://schemas.microsoft.com/office/drawing/2014/main" id="{CF801D58-0903-9C6A-D618-071E4D3E8D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" y="2250"/>
              <a:ext cx="17" cy="17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5" name="Line 13">
              <a:extLst>
                <a:ext uri="{FF2B5EF4-FFF2-40B4-BE49-F238E27FC236}">
                  <a16:creationId xmlns:a16="http://schemas.microsoft.com/office/drawing/2014/main" id="{3324261F-69A4-D2B3-E73A-1DE8295D3D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2127"/>
              <a:ext cx="1" cy="2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6" name="Line 14">
              <a:extLst>
                <a:ext uri="{FF2B5EF4-FFF2-40B4-BE49-F238E27FC236}">
                  <a16:creationId xmlns:a16="http://schemas.microsoft.com/office/drawing/2014/main" id="{F6B8DE4E-9787-A753-71BB-C299E93A6A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6" y="2347"/>
              <a:ext cx="2" cy="1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7" name="Oval 15">
              <a:extLst>
                <a:ext uri="{FF2B5EF4-FFF2-40B4-BE49-F238E27FC236}">
                  <a16:creationId xmlns:a16="http://schemas.microsoft.com/office/drawing/2014/main" id="{1055DFC9-1FF8-07D2-41E8-0F33F28DC5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6" y="2311"/>
              <a:ext cx="61" cy="61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8" name="Oval 16">
              <a:extLst>
                <a:ext uri="{FF2B5EF4-FFF2-40B4-BE49-F238E27FC236}">
                  <a16:creationId xmlns:a16="http://schemas.microsoft.com/office/drawing/2014/main" id="{E11D935A-2255-43CE-9751-BE4D680F88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7" y="2313"/>
              <a:ext cx="57" cy="56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9" name="Oval 17">
              <a:extLst>
                <a:ext uri="{FF2B5EF4-FFF2-40B4-BE49-F238E27FC236}">
                  <a16:creationId xmlns:a16="http://schemas.microsoft.com/office/drawing/2014/main" id="{2ADCB792-A914-3838-3525-7D76F9AA6F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" y="2311"/>
              <a:ext cx="67" cy="66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0" name="Oval 18">
              <a:extLst>
                <a:ext uri="{FF2B5EF4-FFF2-40B4-BE49-F238E27FC236}">
                  <a16:creationId xmlns:a16="http://schemas.microsoft.com/office/drawing/2014/main" id="{273E26F9-75BD-FC62-1F94-F6CAB02CF8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" y="2311"/>
              <a:ext cx="67" cy="66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1" name="Line 19">
              <a:extLst>
                <a:ext uri="{FF2B5EF4-FFF2-40B4-BE49-F238E27FC236}">
                  <a16:creationId xmlns:a16="http://schemas.microsoft.com/office/drawing/2014/main" id="{D18BCC90-5E19-1B85-7DFA-30B48DF4F5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380"/>
              <a:ext cx="1" cy="1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2" name="Line 20">
              <a:extLst>
                <a:ext uri="{FF2B5EF4-FFF2-40B4-BE49-F238E27FC236}">
                  <a16:creationId xmlns:a16="http://schemas.microsoft.com/office/drawing/2014/main" id="{18033693-C4E5-B5D8-7C7A-122B1A98F3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792"/>
              <a:ext cx="1" cy="2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3" name="Line 21">
              <a:extLst>
                <a:ext uri="{FF2B5EF4-FFF2-40B4-BE49-F238E27FC236}">
                  <a16:creationId xmlns:a16="http://schemas.microsoft.com/office/drawing/2014/main" id="{45EA3D91-1561-9899-D931-A7AFA231A8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667"/>
              <a:ext cx="1" cy="2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4" name="Oval 22">
              <a:extLst>
                <a:ext uri="{FF2B5EF4-FFF2-40B4-BE49-F238E27FC236}">
                  <a16:creationId xmlns:a16="http://schemas.microsoft.com/office/drawing/2014/main" id="{90D8FCB6-1B55-829E-8CA8-75CAA5D454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" y="1407"/>
              <a:ext cx="28" cy="28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5" name="Oval 23">
              <a:extLst>
                <a:ext uri="{FF2B5EF4-FFF2-40B4-BE49-F238E27FC236}">
                  <a16:creationId xmlns:a16="http://schemas.microsoft.com/office/drawing/2014/main" id="{8F821065-6CB1-182F-1CDF-1CB5EA1530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" y="1749"/>
              <a:ext cx="172" cy="171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6" name="Oval 24">
              <a:extLst>
                <a:ext uri="{FF2B5EF4-FFF2-40B4-BE49-F238E27FC236}">
                  <a16:creationId xmlns:a16="http://schemas.microsoft.com/office/drawing/2014/main" id="{7C154C20-BD0E-2D17-1913-1E521E78F6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" y="1912"/>
              <a:ext cx="26" cy="26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7" name="Oval 25">
              <a:extLst>
                <a:ext uri="{FF2B5EF4-FFF2-40B4-BE49-F238E27FC236}">
                  <a16:creationId xmlns:a16="http://schemas.microsoft.com/office/drawing/2014/main" id="{3E616417-EA28-C82B-4522-A2FEAEE74A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" y="2045"/>
              <a:ext cx="29" cy="28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8" name="Line 26">
              <a:extLst>
                <a:ext uri="{FF2B5EF4-FFF2-40B4-BE49-F238E27FC236}">
                  <a16:creationId xmlns:a16="http://schemas.microsoft.com/office/drawing/2014/main" id="{7B3B1DAE-2B24-2863-F3D1-17F3D730F1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945"/>
              <a:ext cx="1" cy="1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9" name="Line 27">
              <a:extLst>
                <a:ext uri="{FF2B5EF4-FFF2-40B4-BE49-F238E27FC236}">
                  <a16:creationId xmlns:a16="http://schemas.microsoft.com/office/drawing/2014/main" id="{D68BDBFE-E353-75AA-C594-1C5E15E1E5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579"/>
              <a:ext cx="1" cy="2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0" name="Line 28">
              <a:extLst>
                <a:ext uri="{FF2B5EF4-FFF2-40B4-BE49-F238E27FC236}">
                  <a16:creationId xmlns:a16="http://schemas.microsoft.com/office/drawing/2014/main" id="{A735EECF-D1A1-1322-5C77-04DAB3B4B5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477"/>
              <a:ext cx="1" cy="1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1" name="Line 29">
              <a:extLst>
                <a:ext uri="{FF2B5EF4-FFF2-40B4-BE49-F238E27FC236}">
                  <a16:creationId xmlns:a16="http://schemas.microsoft.com/office/drawing/2014/main" id="{887D95A8-3AEA-8617-0DFA-C312BCFCDD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734"/>
              <a:ext cx="1" cy="2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2" name="Line 30">
              <a:extLst>
                <a:ext uri="{FF2B5EF4-FFF2-40B4-BE49-F238E27FC236}">
                  <a16:creationId xmlns:a16="http://schemas.microsoft.com/office/drawing/2014/main" id="{2CD314B0-B1A5-652F-AFDA-DE8A898DA4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724"/>
              <a:ext cx="1" cy="1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3" name="Line 31">
              <a:extLst>
                <a:ext uri="{FF2B5EF4-FFF2-40B4-BE49-F238E27FC236}">
                  <a16:creationId xmlns:a16="http://schemas.microsoft.com/office/drawing/2014/main" id="{31E0385F-D5B2-C47D-32B3-2773ABF865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614"/>
              <a:ext cx="1" cy="1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4" name="Line 32">
              <a:extLst>
                <a:ext uri="{FF2B5EF4-FFF2-40B4-BE49-F238E27FC236}">
                  <a16:creationId xmlns:a16="http://schemas.microsoft.com/office/drawing/2014/main" id="{F48F1182-A3BE-6C2E-9D2B-CB7D7E697F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1598"/>
              <a:ext cx="1" cy="1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5" name="Oval 33">
              <a:extLst>
                <a:ext uri="{FF2B5EF4-FFF2-40B4-BE49-F238E27FC236}">
                  <a16:creationId xmlns:a16="http://schemas.microsoft.com/office/drawing/2014/main" id="{DA95B35A-62AC-2D83-F549-54A0233451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4" y="2021"/>
              <a:ext cx="86" cy="85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6" name="Line 34">
              <a:extLst>
                <a:ext uri="{FF2B5EF4-FFF2-40B4-BE49-F238E27FC236}">
                  <a16:creationId xmlns:a16="http://schemas.microsoft.com/office/drawing/2014/main" id="{6BFE236F-0CC5-8677-C50B-C0A79DC70F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6" y="2431"/>
              <a:ext cx="2" cy="1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7" name="Oval 35">
              <a:extLst>
                <a:ext uri="{FF2B5EF4-FFF2-40B4-BE49-F238E27FC236}">
                  <a16:creationId xmlns:a16="http://schemas.microsoft.com/office/drawing/2014/main" id="{09C74407-0FFC-92D2-9512-5D378DC229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" y="2190"/>
              <a:ext cx="9" cy="10"/>
            </a:xfrm>
            <a:prstGeom prst="ellips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8" name="Freeform 36">
              <a:extLst>
                <a:ext uri="{FF2B5EF4-FFF2-40B4-BE49-F238E27FC236}">
                  <a16:creationId xmlns:a16="http://schemas.microsoft.com/office/drawing/2014/main" id="{D196FB39-CB09-B882-D27C-B8455CA94E6B}"/>
                </a:ext>
              </a:extLst>
            </p:cNvPr>
            <p:cNvSpPr>
              <a:spLocks/>
            </p:cNvSpPr>
            <p:nvPr/>
          </p:nvSpPr>
          <p:spPr bwMode="auto">
            <a:xfrm>
              <a:off x="655" y="1976"/>
              <a:ext cx="1843" cy="346"/>
            </a:xfrm>
            <a:custGeom>
              <a:avLst/>
              <a:gdLst>
                <a:gd name="T0" fmla="*/ 0 w 1392"/>
                <a:gd name="T1" fmla="*/ 0 h 263"/>
                <a:gd name="T2" fmla="*/ 0 w 1392"/>
                <a:gd name="T3" fmla="*/ 0 h 263"/>
                <a:gd name="T4" fmla="*/ 0 w 1392"/>
                <a:gd name="T5" fmla="*/ 0 h 263"/>
                <a:gd name="T6" fmla="*/ 0 w 1392"/>
                <a:gd name="T7" fmla="*/ 0 h 263"/>
                <a:gd name="T8" fmla="*/ 0 w 1392"/>
                <a:gd name="T9" fmla="*/ 0 h 263"/>
                <a:gd name="T10" fmla="*/ 0 w 1392"/>
                <a:gd name="T11" fmla="*/ 0 h 263"/>
                <a:gd name="T12" fmla="*/ 0 w 1392"/>
                <a:gd name="T13" fmla="*/ 0 h 263"/>
                <a:gd name="T14" fmla="*/ 0 w 1392"/>
                <a:gd name="T15" fmla="*/ 0 h 263"/>
                <a:gd name="T16" fmla="*/ 0 w 1392"/>
                <a:gd name="T17" fmla="*/ 0 h 263"/>
                <a:gd name="T18" fmla="*/ 0 w 1392"/>
                <a:gd name="T19" fmla="*/ 0 h 263"/>
                <a:gd name="T20" fmla="*/ 0 w 1392"/>
                <a:gd name="T21" fmla="*/ 0 h 263"/>
                <a:gd name="T22" fmla="*/ 0 w 1392"/>
                <a:gd name="T23" fmla="*/ 0 h 263"/>
                <a:gd name="T24" fmla="*/ 0 w 1392"/>
                <a:gd name="T25" fmla="*/ 0 h 263"/>
                <a:gd name="T26" fmla="*/ 0 w 1392"/>
                <a:gd name="T27" fmla="*/ 0 h 263"/>
                <a:gd name="T28" fmla="*/ 0 w 1392"/>
                <a:gd name="T29" fmla="*/ 0 h 263"/>
                <a:gd name="T30" fmla="*/ 0 w 1392"/>
                <a:gd name="T31" fmla="*/ 0 h 263"/>
                <a:gd name="T32" fmla="*/ 696 w 1392"/>
                <a:gd name="T33" fmla="*/ 132 h 263"/>
                <a:gd name="T34" fmla="*/ 696 w 1392"/>
                <a:gd name="T35" fmla="*/ 132 h 263"/>
                <a:gd name="T36" fmla="*/ 696 w 1392"/>
                <a:gd name="T37" fmla="*/ 132 h 263"/>
                <a:gd name="T38" fmla="*/ 696 w 1392"/>
                <a:gd name="T39" fmla="*/ 132 h 263"/>
                <a:gd name="T40" fmla="*/ 696 w 1392"/>
                <a:gd name="T41" fmla="*/ 132 h 263"/>
                <a:gd name="T42" fmla="*/ 696 w 1392"/>
                <a:gd name="T43" fmla="*/ 132 h 263"/>
                <a:gd name="T44" fmla="*/ 1392 w 1392"/>
                <a:gd name="T45" fmla="*/ 263 h 263"/>
                <a:gd name="T46" fmla="*/ 1392 w 1392"/>
                <a:gd name="T47" fmla="*/ 263 h 2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1392" h="263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696" y="132"/>
                  </a:lnTo>
                  <a:lnTo>
                    <a:pt x="696" y="132"/>
                  </a:lnTo>
                  <a:lnTo>
                    <a:pt x="696" y="132"/>
                  </a:lnTo>
                  <a:lnTo>
                    <a:pt x="696" y="132"/>
                  </a:lnTo>
                  <a:lnTo>
                    <a:pt x="696" y="132"/>
                  </a:lnTo>
                  <a:lnTo>
                    <a:pt x="696" y="132"/>
                  </a:lnTo>
                  <a:lnTo>
                    <a:pt x="1392" y="263"/>
                  </a:lnTo>
                  <a:lnTo>
                    <a:pt x="1392" y="263"/>
                  </a:lnTo>
                </a:path>
              </a:pathLst>
            </a:cu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9" name="Line 37">
              <a:extLst>
                <a:ext uri="{FF2B5EF4-FFF2-40B4-BE49-F238E27FC236}">
                  <a16:creationId xmlns:a16="http://schemas.microsoft.com/office/drawing/2014/main" id="{C25F34D4-66FC-EE52-CE8E-271CED8E86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1" y="1188"/>
              <a:ext cx="0" cy="1306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40" name="Line 38">
              <a:extLst>
                <a:ext uri="{FF2B5EF4-FFF2-40B4-BE49-F238E27FC236}">
                  <a16:creationId xmlns:a16="http://schemas.microsoft.com/office/drawing/2014/main" id="{A3D3B993-A29F-D03B-6192-B5AEF5E328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2460"/>
              <a:ext cx="2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41" name="Rectangle 39">
              <a:extLst>
                <a:ext uri="{FF2B5EF4-FFF2-40B4-BE49-F238E27FC236}">
                  <a16:creationId xmlns:a16="http://schemas.microsoft.com/office/drawing/2014/main" id="{3C5DF6F1-8F01-5560-8845-493642ADE8D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32" y="2406"/>
              <a:ext cx="57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Line 40">
              <a:extLst>
                <a:ext uri="{FF2B5EF4-FFF2-40B4-BE49-F238E27FC236}">
                  <a16:creationId xmlns:a16="http://schemas.microsoft.com/office/drawing/2014/main" id="{1F0C2AAC-33A5-EFEE-550E-BD73B3EB16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2047"/>
              <a:ext cx="2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43" name="Rectangle 41">
              <a:extLst>
                <a:ext uri="{FF2B5EF4-FFF2-40B4-BE49-F238E27FC236}">
                  <a16:creationId xmlns:a16="http://schemas.microsoft.com/office/drawing/2014/main" id="{01C3B461-05E1-61A8-89FB-4F060CAB846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43" y="2011"/>
              <a:ext cx="35" cy="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50</a:t>
              </a:r>
              <a:endParaRPr kumimoji="0" lang="el-GR" altLang="el-G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44" name="Line 42">
              <a:extLst>
                <a:ext uri="{FF2B5EF4-FFF2-40B4-BE49-F238E27FC236}">
                  <a16:creationId xmlns:a16="http://schemas.microsoft.com/office/drawing/2014/main" id="{AA06D743-BB46-7556-520B-9639DBAF58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1635"/>
              <a:ext cx="2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45" name="Rectangle 43">
              <a:extLst>
                <a:ext uri="{FF2B5EF4-FFF2-40B4-BE49-F238E27FC236}">
                  <a16:creationId xmlns:a16="http://schemas.microsoft.com/office/drawing/2014/main" id="{12193F13-91CC-AEEE-AA35-3BFF5D11CDA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34" y="1597"/>
              <a:ext cx="52" cy="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100</a:t>
              </a:r>
              <a:endParaRPr kumimoji="0" lang="el-GR" altLang="el-G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46" name="Line 44">
              <a:extLst>
                <a:ext uri="{FF2B5EF4-FFF2-40B4-BE49-F238E27FC236}">
                  <a16:creationId xmlns:a16="http://schemas.microsoft.com/office/drawing/2014/main" id="{F253D3AE-5D4F-25F4-45BF-A22BE03450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1222"/>
              <a:ext cx="23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47" name="Rectangle 45">
              <a:extLst>
                <a:ext uri="{FF2B5EF4-FFF2-40B4-BE49-F238E27FC236}">
                  <a16:creationId xmlns:a16="http://schemas.microsoft.com/office/drawing/2014/main" id="{2ECD4870-4AF9-6797-3513-B8C20D69C3D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34" y="1185"/>
              <a:ext cx="52" cy="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150</a:t>
              </a:r>
              <a:endParaRPr kumimoji="0" lang="el-GR" altLang="el-G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48" name="Rectangle 46">
              <a:extLst>
                <a:ext uri="{FF2B5EF4-FFF2-40B4-BE49-F238E27FC236}">
                  <a16:creationId xmlns:a16="http://schemas.microsoft.com/office/drawing/2014/main" id="{B2C28416-7840-5D69-E010-CC3154F27D4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37" y="1710"/>
              <a:ext cx="222" cy="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sz="1600" b="1" kern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mg / g</a:t>
              </a:r>
              <a:endParaRPr lang="el-GR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l-GR" altLang="el-G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Line 47">
              <a:extLst>
                <a:ext uri="{FF2B5EF4-FFF2-40B4-BE49-F238E27FC236}">
                  <a16:creationId xmlns:a16="http://schemas.microsoft.com/office/drawing/2014/main" id="{BFD3EACF-6F3D-33E9-4CFC-CE0E761B6E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1" y="2494"/>
              <a:ext cx="1911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0" name="Line 48">
              <a:extLst>
                <a:ext uri="{FF2B5EF4-FFF2-40B4-BE49-F238E27FC236}">
                  <a16:creationId xmlns:a16="http://schemas.microsoft.com/office/drawing/2014/main" id="{29AF7CB1-28DE-EFFC-9F2C-C186E863A3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5" y="2494"/>
              <a:ext cx="0" cy="22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1" name="Rectangle 49">
              <a:extLst>
                <a:ext uri="{FF2B5EF4-FFF2-40B4-BE49-F238E27FC236}">
                  <a16:creationId xmlns:a16="http://schemas.microsoft.com/office/drawing/2014/main" id="{741BF1B8-068C-1798-60DF-9166B1E2CF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" y="2536"/>
              <a:ext cx="204" cy="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l-GR" sz="1000" b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m</a:t>
              </a:r>
              <a:r>
                <a:rPr kumimoji="0" lang="en-US" altLang="el-GR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g TE/g</a:t>
              </a:r>
              <a:endParaRPr kumimoji="0" lang="el-GR" altLang="el-GR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52" name="Line 50">
              <a:extLst>
                <a:ext uri="{FF2B5EF4-FFF2-40B4-BE49-F238E27FC236}">
                  <a16:creationId xmlns:a16="http://schemas.microsoft.com/office/drawing/2014/main" id="{AAC803D0-FAF4-B773-3E8A-53A67905B9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16" y="2494"/>
              <a:ext cx="0" cy="22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4" name="Line 52">
              <a:extLst>
                <a:ext uri="{FF2B5EF4-FFF2-40B4-BE49-F238E27FC236}">
                  <a16:creationId xmlns:a16="http://schemas.microsoft.com/office/drawing/2014/main" id="{45F557BD-8EB4-8BA1-67DC-1DF2CB59AA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6" y="2494"/>
              <a:ext cx="0" cy="22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5" name="Rectangle 53">
              <a:extLst>
                <a:ext uri="{FF2B5EF4-FFF2-40B4-BE49-F238E27FC236}">
                  <a16:creationId xmlns:a16="http://schemas.microsoft.com/office/drawing/2014/main" id="{6D37A31F-4E7E-1D86-6E3C-FCADBFD7A6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7" y="2541"/>
              <a:ext cx="232" cy="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l-GR" sz="1000" b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m</a:t>
              </a:r>
              <a:r>
                <a:rPr kumimoji="0" lang="en-US" altLang="el-GR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g AAE/</a:t>
              </a:r>
              <a:r>
                <a:rPr kumimoji="0" lang="en-US" altLang="el-G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g</a:t>
              </a:r>
              <a:endParaRPr kumimoji="0" lang="el-GR" altLang="el-G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56" name="Line 54">
              <a:extLst>
                <a:ext uri="{FF2B5EF4-FFF2-40B4-BE49-F238E27FC236}">
                  <a16:creationId xmlns:a16="http://schemas.microsoft.com/office/drawing/2014/main" id="{8D5E45BC-CF9E-6505-A3EC-14DECDC2A2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7" y="2494"/>
              <a:ext cx="0" cy="22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8" name="Line 56">
              <a:extLst>
                <a:ext uri="{FF2B5EF4-FFF2-40B4-BE49-F238E27FC236}">
                  <a16:creationId xmlns:a16="http://schemas.microsoft.com/office/drawing/2014/main" id="{7DC2B59D-5A15-5410-CA1C-4C6F1A6FE8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8" y="2494"/>
              <a:ext cx="0" cy="22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9" name="Rectangle 57">
              <a:extLst>
                <a:ext uri="{FF2B5EF4-FFF2-40B4-BE49-F238E27FC236}">
                  <a16:creationId xmlns:a16="http://schemas.microsoft.com/office/drawing/2014/main" id="{8D7D9209-39CE-2A44-E40F-F33333B54D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3" y="2527"/>
              <a:ext cx="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l-GR" altLang="el-G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64" name="Rectangle 53">
            <a:extLst>
              <a:ext uri="{FF2B5EF4-FFF2-40B4-BE49-F238E27FC236}">
                <a16:creationId xmlns:a16="http://schemas.microsoft.com/office/drawing/2014/main" id="{CF8D88B8-A3DD-32E2-213D-257EEDB8EB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25062" y="5117797"/>
            <a:ext cx="56105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l-GR" sz="10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m</a:t>
            </a:r>
            <a:r>
              <a:rPr kumimoji="0" lang="en-US" altLang="el-GR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g RUE</a:t>
            </a:r>
            <a:r>
              <a:rPr kumimoji="0" lang="en-US" altLang="el-GR" sz="7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/g</a:t>
            </a:r>
            <a:endParaRPr kumimoji="0" lang="el-GR" altLang="el-GR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AFD1FDF-A6F5-7634-E602-B8961E774B0C}"/>
              </a:ext>
            </a:extLst>
          </p:cNvPr>
          <p:cNvSpPr txBox="1"/>
          <p:nvPr/>
        </p:nvSpPr>
        <p:spPr>
          <a:xfrm>
            <a:off x="5268919" y="1657015"/>
            <a:ext cx="13056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200" b="1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value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= 0.144</a:t>
            </a:r>
            <a:endParaRPr lang="el-GR" sz="1200" b="1" dirty="0">
              <a:latin typeface="Palatino Linotype" panose="02040502050505030304" pitchFamily="18" charset="0"/>
            </a:endParaRPr>
          </a:p>
        </p:txBody>
      </p:sp>
      <p:sp>
        <p:nvSpPr>
          <p:cNvPr id="3" name="Rectangle 43">
            <a:extLst>
              <a:ext uri="{FF2B5EF4-FFF2-40B4-BE49-F238E27FC236}">
                <a16:creationId xmlns:a16="http://schemas.microsoft.com/office/drawing/2014/main" id="{8FA29789-9152-A61E-D820-47551DC0F1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99966" y="5318062"/>
            <a:ext cx="8720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l-GR" sz="16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u</a:t>
            </a:r>
            <a:r>
              <a:rPr kumimoji="0" lang="el-GR" altLang="el-GR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nit</a:t>
            </a:r>
            <a:r>
              <a:rPr lang="en-US" altLang="el-GR" sz="16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 </a:t>
            </a:r>
            <a:r>
              <a:rPr kumimoji="0" lang="el-GR" altLang="el-GR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code</a:t>
            </a:r>
            <a:endParaRPr kumimoji="0" lang="el-GR" altLang="el-GR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CB5E7E7-790C-5880-8777-BA75D32B42FB}"/>
              </a:ext>
            </a:extLst>
          </p:cNvPr>
          <p:cNvSpPr txBox="1"/>
          <p:nvPr/>
        </p:nvSpPr>
        <p:spPr>
          <a:xfrm>
            <a:off x="5268919" y="1910015"/>
            <a:ext cx="13056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ydroalcoholic</a:t>
            </a:r>
            <a:endParaRPr lang="el-GR" sz="12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8936493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Θέμα του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</TotalTime>
  <Words>45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Θέμα του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PAPAEFTHYMIOU MARIA</dc:creator>
  <cp:lastModifiedBy>MDPI</cp:lastModifiedBy>
  <cp:revision>2</cp:revision>
  <dcterms:created xsi:type="dcterms:W3CDTF">2024-03-21T04:30:03Z</dcterms:created>
  <dcterms:modified xsi:type="dcterms:W3CDTF">2024-06-04T12:26:26Z</dcterms:modified>
</cp:coreProperties>
</file>